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9144000" cy="6858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69696"/>
    <a:srgbClr val="C0C0C0"/>
    <a:srgbClr val="EAEAE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195" autoAdjust="0"/>
    <p:restoredTop sz="94660"/>
  </p:normalViewPr>
  <p:slideViewPr>
    <p:cSldViewPr snapToGrid="0">
      <p:cViewPr varScale="1">
        <p:scale>
          <a:sx n="74" d="100"/>
          <a:sy n="74" d="100"/>
        </p:scale>
        <p:origin x="129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3012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6016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9200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499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56144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0473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22321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818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7742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1326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2238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3602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Group 10">
            <a:extLst>
              <a:ext uri="{FF2B5EF4-FFF2-40B4-BE49-F238E27FC236}">
                <a16:creationId xmlns:a16="http://schemas.microsoft.com/office/drawing/2014/main" id="{BBAD725A-3262-4A98-830A-92A8EDDBE5C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50093958"/>
              </p:ext>
            </p:extLst>
          </p:nvPr>
        </p:nvGraphicFramePr>
        <p:xfrm>
          <a:off x="386351" y="625794"/>
          <a:ext cx="6823702" cy="6094744"/>
        </p:xfrm>
        <a:graphic>
          <a:graphicData uri="http://schemas.openxmlformats.org/drawingml/2006/table">
            <a:tbl>
              <a:tblPr/>
              <a:tblGrid>
                <a:gridCol w="164368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823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0717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2624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4119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2781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26241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541195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32781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511007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2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2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2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3"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eason's  Product-moment correlation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3765" marR="93765" marT="46882" marB="46882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pearman's rank difference correlation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3765" marR="93765" marT="46882" marB="46882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358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Variation 1</a:t>
                      </a:r>
                      <a:endParaRPr kumimoji="1" lang="en-US" altLang="ja-JP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Variation 2</a:t>
                      </a:r>
                      <a:endParaRPr kumimoji="1" lang="en-US" altLang="ja-JP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n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ｒ</a:t>
                      </a:r>
                      <a:endParaRPr kumimoji="1" lang="ja-JP" altLang="en-US" sz="9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 value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3765" marR="93765" marT="46882" marB="46882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ρ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 value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3765" marR="93765" marT="46882" marB="46882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358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tumor  volume %change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FS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9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795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08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*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748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34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358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tumor  volume %change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 1  Post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9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08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05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17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70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5358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15  Pre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9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86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45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50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71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358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15  Post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9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41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28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50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71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5358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29  Pre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9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76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63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17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39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5358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29  Post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9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08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05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33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46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5358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 1  Post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9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57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19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17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41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5358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15  Pre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9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66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82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267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51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5358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15  Post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9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65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83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17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41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5358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29  Pre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9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71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861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83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78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5358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29  Post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9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23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62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00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58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5358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FS (days)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 1  Post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9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070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865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84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812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5358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15  Pre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9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72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71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252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76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5358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15  Post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9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21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65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008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981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5358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29  Pre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9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600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90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664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60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5358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29  Post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9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626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72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571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06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5358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 1  Post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9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065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873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36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42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5358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15  Pre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9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201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17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18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39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5358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15  Post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9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52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07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43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86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5358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29  Pre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9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510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68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647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67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5358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29  Post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9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568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14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672 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57</a:t>
                      </a:r>
                      <a:endParaRPr kumimoji="1" lang="en-US" altLang="ja-JP" sz="9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0" fontAlgn="ctr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9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entury" panose="02040604050505020304" pitchFamily="18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9065" marR="89065" marT="44533" marB="44533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</a:tbl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F80D193-ABC7-441D-BF0C-C68455FFA00D}"/>
              </a:ext>
            </a:extLst>
          </p:cNvPr>
          <p:cNvSpPr txBox="1"/>
          <p:nvPr/>
        </p:nvSpPr>
        <p:spPr>
          <a:xfrm>
            <a:off x="301801" y="12962"/>
            <a:ext cx="7012048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7. Correlation between serum sCD26/DPP4 titer variation (%) and tumor volume </a:t>
            </a:r>
          </a:p>
          <a:p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 (%) or PFS (days) in 9 MM, male cases with Q2W administration by PPMC or SRDC analysis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387568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8</TotalTime>
  <Words>325</Words>
  <Application>Microsoft Office PowerPoint</Application>
  <PresentationFormat>画面に合わせる (4:3)</PresentationFormat>
  <Paragraphs>20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Arial Unicode MS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tan</dc:creator>
  <cp:lastModifiedBy> </cp:lastModifiedBy>
  <cp:revision>51</cp:revision>
  <cp:lastPrinted>2020-10-09T00:45:33Z</cp:lastPrinted>
  <dcterms:created xsi:type="dcterms:W3CDTF">2020-04-13T08:26:21Z</dcterms:created>
  <dcterms:modified xsi:type="dcterms:W3CDTF">2020-12-08T18:17:35Z</dcterms:modified>
</cp:coreProperties>
</file>